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335713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32080" y="685440"/>
            <a:ext cx="2193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61D08C-FF5D-4FBC-87D5-0C842214F343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sldImg"/>
          </p:nvPr>
        </p:nvSpPr>
        <p:spPr>
          <a:xfrm>
            <a:off x="2332080" y="685800"/>
            <a:ext cx="2193840" cy="3429000"/>
          </a:xfrm>
          <a:prstGeom prst="rect">
            <a:avLst/>
          </a:prstGeom>
          <a:ln w="0">
            <a:noFill/>
          </a:ln>
        </p:spPr>
      </p:sp>
      <p:sp>
        <p:nvSpPr>
          <p:cNvPr id="13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6B5BA4-EB67-4888-A018-99499C6C404A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74ECC-49E4-4824-B107-CD4CF40E76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4821E-0A3F-4753-ABF6-2FCE39E32C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74D17-1D41-4BDB-B241-2D3DB9AED3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09A91-6237-4852-B032-5698E7AE04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9F30F-6B33-4323-A2E9-0EEE3DF3E7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3B671-60F8-4FA1-9094-59F886C05B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2DD0A9-86C7-4A6D-AF4C-507310841B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ED5770-734B-47DE-98ED-F9E09B0B2C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396360"/>
            <a:ext cx="57024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8617B0-A0E2-43C0-B70B-B61FF95756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3AD2A-9987-4B76-A966-942093981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D443A-3799-4A67-9134-5DA812E0FE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EBB81-B42F-4D8A-BE9D-7F7ADBC63D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9182160"/>
            <a:ext cx="1477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9182160"/>
            <a:ext cx="200664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9182160"/>
            <a:ext cx="14781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9D21E4-F495-478C-A31F-3A72DE72F6DD}" type="slidenum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142"/>
          <p:cNvSpPr/>
          <p:nvPr/>
        </p:nvSpPr>
        <p:spPr>
          <a:xfrm>
            <a:off x="-360" y="229392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142"/>
          <p:cNvSpPr/>
          <p:nvPr/>
        </p:nvSpPr>
        <p:spPr>
          <a:xfrm>
            <a:off x="6840" y="4470480"/>
            <a:ext cx="2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42"/>
          <p:cNvSpPr/>
          <p:nvPr/>
        </p:nvSpPr>
        <p:spPr>
          <a:xfrm>
            <a:off x="-360" y="664200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41"/>
          <p:cNvSpPr/>
          <p:nvPr/>
        </p:nvSpPr>
        <p:spPr>
          <a:xfrm>
            <a:off x="-25560" y="0"/>
            <a:ext cx="176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S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42"/>
          <p:cNvSpPr/>
          <p:nvPr/>
        </p:nvSpPr>
        <p:spPr>
          <a:xfrm>
            <a:off x="1440" y="27792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グループ化 131"/>
          <p:cNvGrpSpPr/>
          <p:nvPr/>
        </p:nvGrpSpPr>
        <p:grpSpPr>
          <a:xfrm>
            <a:off x="38160" y="4533840"/>
            <a:ext cx="6210360" cy="1812960"/>
            <a:chOff x="38160" y="4533840"/>
            <a:chExt cx="6210360" cy="1812960"/>
          </a:xfrm>
        </p:grpSpPr>
        <p:pic>
          <p:nvPicPr>
            <p:cNvPr id="54" name="Picture 14" descr="E:\マイドキュメント（同期）\C7059\Immunocytochemistry\130610 RKO-3F-C7059 LoVo FA and invadopodia proteins\RKO_3F_C7059_Flag_Cortactin_actin_4_180x180_Flag.tif"/>
            <p:cNvPicPr/>
            <p:nvPr/>
          </p:nvPicPr>
          <p:blipFill>
            <a:blip r:embed="rId1"/>
            <a:stretch/>
          </p:blipFill>
          <p:spPr>
            <a:xfrm>
              <a:off x="1592280" y="47988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55" name="Picture 15" descr="E:\マイドキュメント（同期）\C7059\Immunocytochemistry\130610 RKO-3F-C7059 LoVo FA and invadopodia proteins\RKO_3F_C7059_Flag_Cortactin_actin_4_180x180_Cortactin.tif"/>
            <p:cNvPicPr/>
            <p:nvPr/>
          </p:nvPicPr>
          <p:blipFill>
            <a:blip r:embed="rId2"/>
            <a:stretch/>
          </p:blipFill>
          <p:spPr>
            <a:xfrm>
              <a:off x="38160" y="47988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56" name="Picture 16" descr="E:\マイドキュメント（同期）\C7059\Immunocytochemistry\130610 RKO-3F-C7059 LoVo FA and invadopodia proteins\RKO_3F_C7059_Flag_Cortactin_actin_4_180x180_Actin.tif"/>
            <p:cNvPicPr/>
            <p:nvPr/>
          </p:nvPicPr>
          <p:blipFill>
            <a:blip r:embed="rId3"/>
            <a:stretch/>
          </p:blipFill>
          <p:spPr>
            <a:xfrm>
              <a:off x="3146400" y="47988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57" name="Picture 17" descr="E:\マイドキュメント（同期）\C7059\Immunocytochemistry\130610 RKO-3F-C7059 LoVo FA and invadopodia proteins\RKO_3F_C7059_Flag_Cortactin_actin_4_180x180_Merge.tif"/>
            <p:cNvPicPr/>
            <p:nvPr/>
          </p:nvPicPr>
          <p:blipFill>
            <a:blip r:embed="rId4"/>
            <a:stretch/>
          </p:blipFill>
          <p:spPr>
            <a:xfrm>
              <a:off x="4700880" y="47988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sp>
          <p:nvSpPr>
            <p:cNvPr id="58" name="テキスト ボックス 25"/>
            <p:cNvSpPr/>
            <p:nvPr/>
          </p:nvSpPr>
          <p:spPr>
            <a:xfrm>
              <a:off x="394560" y="4533840"/>
              <a:ext cx="834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b050"/>
                  </a:solidFill>
                  <a:latin typeface="Arial Unicode MS"/>
                  <a:ea typeface="Arial Unicode MS"/>
                </a:rPr>
                <a:t>Cort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テキスト ボックス 26"/>
            <p:cNvSpPr/>
            <p:nvPr/>
          </p:nvSpPr>
          <p:spPr>
            <a:xfrm>
              <a:off x="1965600" y="4533840"/>
              <a:ext cx="80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テキスト ボックス 27"/>
            <p:cNvSpPr/>
            <p:nvPr/>
          </p:nvSpPr>
          <p:spPr>
            <a:xfrm>
              <a:off x="3585960" y="4533840"/>
              <a:ext cx="66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F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テキスト ボックス 28"/>
            <p:cNvSpPr/>
            <p:nvPr/>
          </p:nvSpPr>
          <p:spPr>
            <a:xfrm>
              <a:off x="5150160" y="453384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2" name="直線矢印コネクタ 49"/>
            <p:cNvCxnSpPr/>
            <p:nvPr/>
          </p:nvCxnSpPr>
          <p:spPr>
            <a:xfrm flipH="1">
              <a:off x="460080" y="545400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3" name="直線矢印コネクタ 50"/>
            <p:cNvCxnSpPr/>
            <p:nvPr/>
          </p:nvCxnSpPr>
          <p:spPr>
            <a:xfrm flipH="1">
              <a:off x="460080" y="557136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4" name="直線矢印コネクタ 61"/>
            <p:cNvCxnSpPr/>
            <p:nvPr/>
          </p:nvCxnSpPr>
          <p:spPr>
            <a:xfrm flipH="1">
              <a:off x="1995120" y="545400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5" name="直線矢印コネクタ 62"/>
            <p:cNvCxnSpPr/>
            <p:nvPr/>
          </p:nvCxnSpPr>
          <p:spPr>
            <a:xfrm flipH="1">
              <a:off x="1995120" y="557136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6" name="直線矢印コネクタ 72"/>
            <p:cNvCxnSpPr/>
            <p:nvPr/>
          </p:nvCxnSpPr>
          <p:spPr>
            <a:xfrm flipH="1">
              <a:off x="3587760" y="5453280"/>
              <a:ext cx="136440" cy="7812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7" name="直線矢印コネクタ 73"/>
            <p:cNvCxnSpPr/>
            <p:nvPr/>
          </p:nvCxnSpPr>
          <p:spPr>
            <a:xfrm flipH="1">
              <a:off x="3587760" y="5570640"/>
              <a:ext cx="136440" cy="7812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8" name="直線矢印コネクタ 83"/>
            <p:cNvCxnSpPr/>
            <p:nvPr/>
          </p:nvCxnSpPr>
          <p:spPr>
            <a:xfrm flipH="1">
              <a:off x="5122800" y="545400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69" name="直線矢印コネクタ 84"/>
            <p:cNvCxnSpPr/>
            <p:nvPr/>
          </p:nvCxnSpPr>
          <p:spPr>
            <a:xfrm flipH="1">
              <a:off x="5122800" y="557136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sp>
          <p:nvSpPr>
            <p:cNvPr id="70" name="直線コネクタ 125"/>
            <p:cNvSpPr/>
            <p:nvPr/>
          </p:nvSpPr>
          <p:spPr>
            <a:xfrm>
              <a:off x="5859720" y="6243840"/>
              <a:ext cx="32364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1" name="グループ化 130"/>
          <p:cNvGrpSpPr/>
          <p:nvPr/>
        </p:nvGrpSpPr>
        <p:grpSpPr>
          <a:xfrm>
            <a:off x="38160" y="6696000"/>
            <a:ext cx="6210360" cy="1809720"/>
            <a:chOff x="38160" y="6696000"/>
            <a:chExt cx="6210360" cy="1809720"/>
          </a:xfrm>
        </p:grpSpPr>
        <p:pic>
          <p:nvPicPr>
            <p:cNvPr id="72" name="Picture 18" descr="E:\マイドキュメント（同期）\C7059\Immunocytochemistry\130610 RKO-3F-C7059 LoVo FA and invadopodia proteins\RKO_3F_C7059_Flag_Arp23_actin_3_180x180_Flag.tif"/>
            <p:cNvPicPr/>
            <p:nvPr/>
          </p:nvPicPr>
          <p:blipFill>
            <a:blip r:embed="rId5"/>
            <a:stretch/>
          </p:blipFill>
          <p:spPr>
            <a:xfrm>
              <a:off x="1592280" y="695772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73" name="Picture 19" descr="E:\マイドキュメント（同期）\C7059\Immunocytochemistry\130610 RKO-3F-C7059 LoVo FA and invadopodia proteins\RKO_3F_C7059_Flag_Arp23_actin_3_180x180_Arp23.tif"/>
            <p:cNvPicPr/>
            <p:nvPr/>
          </p:nvPicPr>
          <p:blipFill>
            <a:blip r:embed="rId6"/>
            <a:stretch/>
          </p:blipFill>
          <p:spPr>
            <a:xfrm>
              <a:off x="38160" y="695772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74" name="Picture 20" descr="E:\マイドキュメント（同期）\C7059\Immunocytochemistry\130610 RKO-3F-C7059 LoVo FA and invadopodia proteins\RKO_3F_C7059_Flag_Arp23_actin_3_180x180_Actin.tif"/>
            <p:cNvPicPr/>
            <p:nvPr/>
          </p:nvPicPr>
          <p:blipFill>
            <a:blip r:embed="rId7"/>
            <a:stretch/>
          </p:blipFill>
          <p:spPr>
            <a:xfrm>
              <a:off x="3146400" y="695772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75" name="Picture 21" descr="E:\マイドキュメント（同期）\C7059\Immunocytochemistry\130610 RKO-3F-C7059 LoVo FA and invadopodia proteins\RKO_3F_C7059_Flag_Arp23_actin_3_180x180_Merge.tif"/>
            <p:cNvPicPr/>
            <p:nvPr/>
          </p:nvPicPr>
          <p:blipFill>
            <a:blip r:embed="rId8"/>
            <a:stretch/>
          </p:blipFill>
          <p:spPr>
            <a:xfrm>
              <a:off x="4700880" y="695772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sp>
          <p:nvSpPr>
            <p:cNvPr id="76" name="テキスト ボックス 33"/>
            <p:cNvSpPr/>
            <p:nvPr/>
          </p:nvSpPr>
          <p:spPr>
            <a:xfrm>
              <a:off x="479160" y="669600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b050"/>
                  </a:solidFill>
                  <a:latin typeface="Arial Unicode MS"/>
                  <a:ea typeface="Arial Unicode MS"/>
                </a:rPr>
                <a:t>Arp2/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テキスト ボックス 34"/>
            <p:cNvSpPr/>
            <p:nvPr/>
          </p:nvSpPr>
          <p:spPr>
            <a:xfrm>
              <a:off x="1965600" y="6696000"/>
              <a:ext cx="80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テキスト ボックス 35"/>
            <p:cNvSpPr/>
            <p:nvPr/>
          </p:nvSpPr>
          <p:spPr>
            <a:xfrm>
              <a:off x="3585960" y="6696000"/>
              <a:ext cx="66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F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テキスト ボックス 36"/>
            <p:cNvSpPr/>
            <p:nvPr/>
          </p:nvSpPr>
          <p:spPr>
            <a:xfrm>
              <a:off x="5150160" y="669600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0" name="直線矢印コネクタ 51"/>
            <p:cNvCxnSpPr/>
            <p:nvPr/>
          </p:nvCxnSpPr>
          <p:spPr>
            <a:xfrm>
              <a:off x="633240" y="737532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81" name="直線矢印コネクタ 63"/>
            <p:cNvCxnSpPr/>
            <p:nvPr/>
          </p:nvCxnSpPr>
          <p:spPr>
            <a:xfrm>
              <a:off x="2212560" y="737532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82" name="直線矢印コネクタ 74"/>
            <p:cNvCxnSpPr/>
            <p:nvPr/>
          </p:nvCxnSpPr>
          <p:spPr>
            <a:xfrm>
              <a:off x="3760200" y="7375320"/>
              <a:ext cx="136440" cy="7812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83" name="直線矢印コネクタ 85"/>
            <p:cNvCxnSpPr/>
            <p:nvPr/>
          </p:nvCxnSpPr>
          <p:spPr>
            <a:xfrm>
              <a:off x="5317920" y="737532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sp>
          <p:nvSpPr>
            <p:cNvPr id="84" name="直線コネクタ 125"/>
            <p:cNvSpPr/>
            <p:nvPr/>
          </p:nvSpPr>
          <p:spPr>
            <a:xfrm>
              <a:off x="5859720" y="8412120"/>
              <a:ext cx="32364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5" name="直線矢印コネクタ 94"/>
            <p:cNvCxnSpPr/>
            <p:nvPr/>
          </p:nvCxnSpPr>
          <p:spPr>
            <a:xfrm>
              <a:off x="542520" y="756396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86" name="直線矢印コネクタ 95"/>
            <p:cNvCxnSpPr/>
            <p:nvPr/>
          </p:nvCxnSpPr>
          <p:spPr>
            <a:xfrm>
              <a:off x="2122200" y="756396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87" name="直線矢印コネクタ 96"/>
            <p:cNvCxnSpPr/>
            <p:nvPr/>
          </p:nvCxnSpPr>
          <p:spPr>
            <a:xfrm>
              <a:off x="3669840" y="7563960"/>
              <a:ext cx="136440" cy="7812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88" name="直線矢印コネクタ 99"/>
            <p:cNvCxnSpPr/>
            <p:nvPr/>
          </p:nvCxnSpPr>
          <p:spPr>
            <a:xfrm>
              <a:off x="5227560" y="7563960"/>
              <a:ext cx="135720" cy="7740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</p:grpSp>
      <p:grpSp>
        <p:nvGrpSpPr>
          <p:cNvPr id="89" name="グループ化 86"/>
          <p:cNvGrpSpPr/>
          <p:nvPr/>
        </p:nvGrpSpPr>
        <p:grpSpPr>
          <a:xfrm>
            <a:off x="54000" y="374760"/>
            <a:ext cx="6049800" cy="1838880"/>
            <a:chOff x="54000" y="374760"/>
            <a:chExt cx="6049800" cy="1838880"/>
          </a:xfrm>
        </p:grpSpPr>
        <p:pic>
          <p:nvPicPr>
            <p:cNvPr id="90" name="Picture 209" descr="K:\マイドキュメント（同期）\C7059\Immunocytochemistry\130517 U2OS ECM degradation assay final\U2OS_ECM_14_120x60_GelatinAF488.tif"/>
            <p:cNvPicPr/>
            <p:nvPr/>
          </p:nvPicPr>
          <p:blipFill>
            <a:blip r:embed="rId9"/>
            <a:stretch/>
          </p:blipFill>
          <p:spPr>
            <a:xfrm>
              <a:off x="3213360" y="1339920"/>
              <a:ext cx="1441080" cy="71892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91" name="Picture 196" descr="E:\マイドキュメント（同期）\C7059\Immunocytochemistry\130517 U2OS ECM degradation assay final\U2OS_ECM_14_120x60_Actin.tif"/>
            <p:cNvPicPr/>
            <p:nvPr/>
          </p:nvPicPr>
          <p:blipFill>
            <a:blip r:embed="rId10"/>
            <a:stretch/>
          </p:blipFill>
          <p:spPr>
            <a:xfrm>
              <a:off x="1764360" y="1339200"/>
              <a:ext cx="143964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92" name="Picture 197" descr="E:\マイドキュメント（同期）\C7059\Immunocytochemistry\130517 U2OS ECM degradation assay final\U2OS_ECM_14_120x60_AFAP1L1.tif"/>
            <p:cNvPicPr/>
            <p:nvPr/>
          </p:nvPicPr>
          <p:blipFill>
            <a:blip r:embed="rId11"/>
            <a:stretch/>
          </p:blipFill>
          <p:spPr>
            <a:xfrm>
              <a:off x="314280" y="1339200"/>
              <a:ext cx="143964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93" name="Picture 200" descr="E:\マイドキュメント（同期）\C7059\Immunocytochemistry\130517 U2OS ECM degradation assay final\U2OS_ECM_14_120x60_Merge.tif"/>
            <p:cNvPicPr/>
            <p:nvPr/>
          </p:nvPicPr>
          <p:blipFill>
            <a:blip r:embed="rId12"/>
            <a:stretch/>
          </p:blipFill>
          <p:spPr>
            <a:xfrm>
              <a:off x="4664160" y="1339200"/>
              <a:ext cx="143964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94" name="Picture 6" descr="E:\マイドキュメント（同期）\C7059\Immunocytochemistry\130517 U2OS ECM degradation assay final\U2OS_ECM_14_300x150_Actin.tif"/>
            <p:cNvPicPr/>
            <p:nvPr/>
          </p:nvPicPr>
          <p:blipFill>
            <a:blip r:embed="rId13"/>
            <a:stretch/>
          </p:blipFill>
          <p:spPr>
            <a:xfrm>
              <a:off x="1764360" y="609840"/>
              <a:ext cx="144000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95" name="Picture 7" descr="E:\マイドキュメント（同期）\C7059\Immunocytochemistry\130517 U2OS ECM degradation assay final\U2OS_ECM_14_300x150_AFAP1L1.tif"/>
            <p:cNvPicPr/>
            <p:nvPr/>
          </p:nvPicPr>
          <p:blipFill>
            <a:blip r:embed="rId14"/>
            <a:stretch/>
          </p:blipFill>
          <p:spPr>
            <a:xfrm>
              <a:off x="314280" y="609840"/>
              <a:ext cx="144000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96" name="Picture 8" descr="E:\マイドキュメント（同期）\C7059\Immunocytochemistry\130517 U2OS ECM degradation assay final\U2OS_ECM_14_300x150_Gelatin-AF488.tif"/>
            <p:cNvPicPr/>
            <p:nvPr/>
          </p:nvPicPr>
          <p:blipFill>
            <a:blip r:embed="rId15"/>
            <a:stretch/>
          </p:blipFill>
          <p:spPr>
            <a:xfrm>
              <a:off x="3214080" y="609840"/>
              <a:ext cx="144000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sp>
          <p:nvSpPr>
            <p:cNvPr id="97" name="テキスト ボックス 47"/>
            <p:cNvSpPr/>
            <p:nvPr/>
          </p:nvSpPr>
          <p:spPr>
            <a:xfrm>
              <a:off x="1960560" y="374760"/>
              <a:ext cx="1047600" cy="26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F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テキスト ボックス 47"/>
            <p:cNvSpPr/>
            <p:nvPr/>
          </p:nvSpPr>
          <p:spPr>
            <a:xfrm>
              <a:off x="3240720" y="374760"/>
              <a:ext cx="1386360" cy="26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b050"/>
                  </a:solidFill>
                  <a:latin typeface="Arial Unicode MS"/>
                  <a:ea typeface="Arial Unicode MS"/>
                </a:rPr>
                <a:t>Gelatin-AF48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47"/>
            <p:cNvSpPr/>
            <p:nvPr/>
          </p:nvSpPr>
          <p:spPr>
            <a:xfrm>
              <a:off x="4860000" y="374760"/>
              <a:ext cx="1047600" cy="26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テキスト ボックス 47"/>
            <p:cNvSpPr/>
            <p:nvPr/>
          </p:nvSpPr>
          <p:spPr>
            <a:xfrm>
              <a:off x="510480" y="374760"/>
              <a:ext cx="1047600" cy="26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テキスト ボックス 47"/>
            <p:cNvSpPr/>
            <p:nvPr/>
          </p:nvSpPr>
          <p:spPr>
            <a:xfrm rot="16200000">
              <a:off x="-181800" y="1200960"/>
              <a:ext cx="740160" cy="26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U2O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2" name="直線矢印コネクタ 112"/>
            <p:cNvCxnSpPr/>
            <p:nvPr/>
          </p:nvCxnSpPr>
          <p:spPr>
            <a:xfrm flipH="1" flipV="1">
              <a:off x="639000" y="1860120"/>
              <a:ext cx="126000" cy="7200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sm" type="triangle" w="sm"/>
            </a:ln>
          </p:spPr>
        </p:cxnSp>
        <p:cxnSp>
          <p:nvCxnSpPr>
            <p:cNvPr id="103" name="直線矢印コネクタ 113"/>
            <p:cNvCxnSpPr/>
            <p:nvPr/>
          </p:nvCxnSpPr>
          <p:spPr>
            <a:xfrm flipH="1">
              <a:off x="720360" y="1459080"/>
              <a:ext cx="107640" cy="6156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sm" type="triangle" w="sm"/>
            </a:ln>
          </p:spPr>
        </p:cxnSp>
        <p:cxnSp>
          <p:nvCxnSpPr>
            <p:cNvPr id="104" name="直線矢印コネクタ 114"/>
            <p:cNvCxnSpPr/>
            <p:nvPr/>
          </p:nvCxnSpPr>
          <p:spPr>
            <a:xfrm flipH="1" flipV="1">
              <a:off x="2098080" y="1860120"/>
              <a:ext cx="126000" cy="7200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sm" type="triangle" w="sm"/>
            </a:ln>
          </p:spPr>
        </p:cxnSp>
        <p:cxnSp>
          <p:nvCxnSpPr>
            <p:cNvPr id="105" name="直線矢印コネクタ 115"/>
            <p:cNvCxnSpPr/>
            <p:nvPr/>
          </p:nvCxnSpPr>
          <p:spPr>
            <a:xfrm flipH="1">
              <a:off x="2179080" y="1458360"/>
              <a:ext cx="109440" cy="6264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sm" type="triangle" w="sm"/>
            </a:ln>
          </p:spPr>
        </p:cxnSp>
        <p:cxnSp>
          <p:nvCxnSpPr>
            <p:cNvPr id="106" name="直線矢印コネクタ 116"/>
            <p:cNvCxnSpPr/>
            <p:nvPr/>
          </p:nvCxnSpPr>
          <p:spPr>
            <a:xfrm flipH="1" flipV="1">
              <a:off x="3563280" y="1860120"/>
              <a:ext cx="126000" cy="7200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sm" type="triangle" w="sm"/>
            </a:ln>
          </p:spPr>
        </p:cxnSp>
        <p:cxnSp>
          <p:nvCxnSpPr>
            <p:cNvPr id="107" name="直線矢印コネクタ 117"/>
            <p:cNvCxnSpPr/>
            <p:nvPr/>
          </p:nvCxnSpPr>
          <p:spPr>
            <a:xfrm flipH="1">
              <a:off x="3642840" y="1458360"/>
              <a:ext cx="109440" cy="6264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sm" type="triangle" w="sm"/>
            </a:ln>
          </p:spPr>
        </p:cxnSp>
        <p:cxnSp>
          <p:nvCxnSpPr>
            <p:cNvPr id="108" name="直線矢印コネクタ 118"/>
            <p:cNvCxnSpPr/>
            <p:nvPr/>
          </p:nvCxnSpPr>
          <p:spPr>
            <a:xfrm flipH="1" flipV="1">
              <a:off x="5022360" y="1860120"/>
              <a:ext cx="126000" cy="7200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sm" type="triangle" w="sm"/>
            </a:ln>
          </p:spPr>
        </p:cxnSp>
        <p:cxnSp>
          <p:nvCxnSpPr>
            <p:cNvPr id="109" name="直線矢印コネクタ 119"/>
            <p:cNvCxnSpPr/>
            <p:nvPr/>
          </p:nvCxnSpPr>
          <p:spPr>
            <a:xfrm flipH="1">
              <a:off x="5103720" y="1459080"/>
              <a:ext cx="107640" cy="61560"/>
            </a:xfrm>
            <a:prstGeom prst="straightConnector1">
              <a:avLst/>
            </a:prstGeom>
            <a:ln w="19080">
              <a:solidFill>
                <a:srgbClr val="ffffff"/>
              </a:solidFill>
              <a:miter/>
              <a:tailEnd len="sm" type="triangle" w="sm"/>
            </a:ln>
          </p:spPr>
        </p:cxnSp>
        <p:pic>
          <p:nvPicPr>
            <p:cNvPr id="110" name="Picture 199" descr="E:\マイドキュメント（同期）\C7059\Immunocytochemistry\130517 U2OS ECM degradation assay final\U2OS_ECM_14_300x150_Merge境界線つき3.tif"/>
            <p:cNvPicPr/>
            <p:nvPr/>
          </p:nvPicPr>
          <p:blipFill>
            <a:blip r:embed="rId16"/>
            <a:stretch/>
          </p:blipFill>
          <p:spPr>
            <a:xfrm>
              <a:off x="4664160" y="609840"/>
              <a:ext cx="1439640" cy="720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sp>
          <p:nvSpPr>
            <p:cNvPr id="111" name="直線コネクタ 125"/>
            <p:cNvSpPr/>
            <p:nvPr/>
          </p:nvSpPr>
          <p:spPr>
            <a:xfrm>
              <a:off x="5861160" y="1265400"/>
              <a:ext cx="179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直線コネクタ 125"/>
            <p:cNvSpPr/>
            <p:nvPr/>
          </p:nvSpPr>
          <p:spPr>
            <a:xfrm>
              <a:off x="5572080" y="2001960"/>
              <a:ext cx="46800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テキスト ボックス 47"/>
            <p:cNvSpPr/>
            <p:nvPr/>
          </p:nvSpPr>
          <p:spPr>
            <a:xfrm>
              <a:off x="864720" y="762480"/>
              <a:ext cx="282240" cy="29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4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テキスト ボックス 47"/>
            <p:cNvSpPr/>
            <p:nvPr/>
          </p:nvSpPr>
          <p:spPr>
            <a:xfrm>
              <a:off x="1561320" y="1041120"/>
              <a:ext cx="282240" cy="29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4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テキスト ボックス 47"/>
            <p:cNvSpPr/>
            <p:nvPr/>
          </p:nvSpPr>
          <p:spPr>
            <a:xfrm>
              <a:off x="232200" y="1369080"/>
              <a:ext cx="282240" cy="29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4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テキスト ボックス 47"/>
            <p:cNvSpPr/>
            <p:nvPr/>
          </p:nvSpPr>
          <p:spPr>
            <a:xfrm>
              <a:off x="1566720" y="1915200"/>
              <a:ext cx="282240" cy="29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4960" rIns="84960" tIns="42480" bIns="4248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4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グループ化 133"/>
          <p:cNvGrpSpPr/>
          <p:nvPr/>
        </p:nvGrpSpPr>
        <p:grpSpPr>
          <a:xfrm>
            <a:off x="38160" y="2367000"/>
            <a:ext cx="6210360" cy="1814400"/>
            <a:chOff x="38160" y="2367000"/>
            <a:chExt cx="6210360" cy="1814400"/>
          </a:xfrm>
        </p:grpSpPr>
        <p:sp>
          <p:nvSpPr>
            <p:cNvPr id="118" name="テキスト ボックス 13"/>
            <p:cNvSpPr/>
            <p:nvPr/>
          </p:nvSpPr>
          <p:spPr>
            <a:xfrm>
              <a:off x="465480" y="2367000"/>
              <a:ext cx="69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b050"/>
                  </a:solidFill>
                  <a:latin typeface="Arial Unicode MS"/>
                  <a:ea typeface="Arial Unicode MS"/>
                </a:rPr>
                <a:t>Paxil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テキスト ボックス 14"/>
            <p:cNvSpPr/>
            <p:nvPr/>
          </p:nvSpPr>
          <p:spPr>
            <a:xfrm>
              <a:off x="1965600" y="2367000"/>
              <a:ext cx="80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テキスト ボックス 15"/>
            <p:cNvSpPr/>
            <p:nvPr/>
          </p:nvSpPr>
          <p:spPr>
            <a:xfrm>
              <a:off x="3585960" y="2367000"/>
              <a:ext cx="66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F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テキスト ボックス 16"/>
            <p:cNvSpPr/>
            <p:nvPr/>
          </p:nvSpPr>
          <p:spPr>
            <a:xfrm>
              <a:off x="5150160" y="236700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2" name="Picture 10" descr="E:\マイドキュメント（同期）\C7059\Immunocytochemistry\130610 RKO-3F-C7059 LoVo FA and invadopodia proteins\RKO_3F_C7059_Flag_Paxillin_actin_4_180x180_Merge.tif"/>
            <p:cNvPicPr/>
            <p:nvPr/>
          </p:nvPicPr>
          <p:blipFill>
            <a:blip r:embed="rId17"/>
            <a:stretch/>
          </p:blipFill>
          <p:spPr>
            <a:xfrm>
              <a:off x="4700880" y="26334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123" name="Picture 11" descr="E:\マイドキュメント（同期）\C7059\Immunocytochemistry\130610 RKO-3F-C7059 LoVo FA and invadopodia proteins\RKO_3F_C7059_Flag_Paxillin_actin_4_180x180_Flag.tif"/>
            <p:cNvPicPr/>
            <p:nvPr/>
          </p:nvPicPr>
          <p:blipFill>
            <a:blip r:embed="rId18"/>
            <a:stretch/>
          </p:blipFill>
          <p:spPr>
            <a:xfrm>
              <a:off x="1592280" y="26334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124" name="Picture 12" descr="E:\マイドキュメント（同期）\C7059\Immunocytochemistry\130610 RKO-3F-C7059 LoVo FA and invadopodia proteins\RKO_3F_C7059_Flag_Paxillin_actin_4_180x180_Paxillin.tif"/>
            <p:cNvPicPr/>
            <p:nvPr/>
          </p:nvPicPr>
          <p:blipFill>
            <a:blip r:embed="rId19"/>
            <a:stretch/>
          </p:blipFill>
          <p:spPr>
            <a:xfrm>
              <a:off x="38160" y="26334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125" name="Picture 13" descr="E:\マイドキュメント（同期）\C7059\Immunocytochemistry\130610 RKO-3F-C7059 LoVo FA and invadopodia proteins\RKO_3F_C7059_Flag_Paxillin_actin_4_180x180_Actin.tif"/>
            <p:cNvPicPr/>
            <p:nvPr/>
          </p:nvPicPr>
          <p:blipFill>
            <a:blip r:embed="rId20"/>
            <a:stretch/>
          </p:blipFill>
          <p:spPr>
            <a:xfrm>
              <a:off x="3146400" y="2633400"/>
              <a:ext cx="1547640" cy="154800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cxnSp>
          <p:nvCxnSpPr>
            <p:cNvPr id="126" name="直線矢印コネクタ 48"/>
            <p:cNvCxnSpPr/>
            <p:nvPr/>
          </p:nvCxnSpPr>
          <p:spPr>
            <a:xfrm flipH="1">
              <a:off x="349920" y="2660400"/>
              <a:ext cx="100440" cy="14724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127" name="直線矢印コネクタ 60"/>
            <p:cNvCxnSpPr/>
            <p:nvPr/>
          </p:nvCxnSpPr>
          <p:spPr>
            <a:xfrm flipH="1">
              <a:off x="1885320" y="2660400"/>
              <a:ext cx="100440" cy="14724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128" name="直線矢印コネクタ 71"/>
            <p:cNvCxnSpPr/>
            <p:nvPr/>
          </p:nvCxnSpPr>
          <p:spPr>
            <a:xfrm flipH="1">
              <a:off x="3477600" y="2660400"/>
              <a:ext cx="100440" cy="14724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129" name="直線矢印コネクタ 82"/>
            <p:cNvCxnSpPr/>
            <p:nvPr/>
          </p:nvCxnSpPr>
          <p:spPr>
            <a:xfrm flipH="1">
              <a:off x="5012640" y="2660400"/>
              <a:ext cx="100440" cy="147240"/>
            </a:xfrm>
            <a:prstGeom prst="straightConnector1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</p:cxnSp>
        <p:sp>
          <p:nvSpPr>
            <p:cNvPr id="130" name="直線コネクタ 125"/>
            <p:cNvSpPr/>
            <p:nvPr/>
          </p:nvSpPr>
          <p:spPr>
            <a:xfrm>
              <a:off x="5859720" y="4083120"/>
              <a:ext cx="32364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下矢印 127"/>
            <p:cNvSpPr/>
            <p:nvPr/>
          </p:nvSpPr>
          <p:spPr>
            <a:xfrm flipH="1" flipV="1" rot="8046000">
              <a:off x="1055160" y="2729160"/>
              <a:ext cx="88560" cy="144360"/>
            </a:xfrm>
            <a:prstGeom prst="downArrow">
              <a:avLst>
                <a:gd name="adj1" fmla="val 50000"/>
                <a:gd name="adj2" fmla="val 50155"/>
              </a:avLst>
            </a:prstGeom>
            <a:noFill/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下矢印 128"/>
            <p:cNvSpPr/>
            <p:nvPr/>
          </p:nvSpPr>
          <p:spPr>
            <a:xfrm flipH="1" flipV="1" rot="8046000">
              <a:off x="4120920" y="2729160"/>
              <a:ext cx="88560" cy="144360"/>
            </a:xfrm>
            <a:prstGeom prst="downArrow">
              <a:avLst>
                <a:gd name="adj1" fmla="val 50000"/>
                <a:gd name="adj2" fmla="val 50155"/>
              </a:avLst>
            </a:prstGeom>
            <a:noFill/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下矢印 129"/>
            <p:cNvSpPr/>
            <p:nvPr/>
          </p:nvSpPr>
          <p:spPr>
            <a:xfrm flipH="1" flipV="1" rot="8046000">
              <a:off x="5732280" y="2729160"/>
              <a:ext cx="88560" cy="144360"/>
            </a:xfrm>
            <a:prstGeom prst="downArrow">
              <a:avLst>
                <a:gd name="adj1" fmla="val 50000"/>
                <a:gd name="adj2" fmla="val 50155"/>
              </a:avLst>
            </a:prstGeom>
            <a:noFill/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0T07:50:08Z</dcterms:created>
  <dc:creator>Ryo　Takahashi</dc:creator>
  <dc:description/>
  <dc:language>en-US</dc:language>
  <cp:lastModifiedBy>戸口田 淳也</cp:lastModifiedBy>
  <dcterms:modified xsi:type="dcterms:W3CDTF">2013-09-16T07:20:56Z</dcterms:modified>
  <cp:revision>50</cp:revision>
  <dc:subject/>
  <dc:title>スライド 1</dc:title>
</cp:coreProperties>
</file>